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80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4D5F9-B17B-87F3-9C2E-867AF24BD5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C96ED7-3AC8-0AB3-CC73-A6375BC479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A8CDD-D80C-3FA1-E1E8-D8D8D00B2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A7BF16-40F8-4E92-24FE-F2B3D2283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C726E9-0289-70BE-DA33-013C7F1AA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030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AAD48-3ED9-9351-4267-C1024C2B62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973EEE-60A4-FD37-5739-E191BBCF0D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1D4A6D-2E42-A845-61A0-4FBD8D006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A9273A-D677-242D-E9BA-D653BE0FB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72D41-F101-8780-A7D3-4636AD3D9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409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DDFCB1-8D60-9784-06C5-B051AEB7FA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86EA3E-6869-55EB-EDD8-2C2549A4DB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29DFC8-F921-6628-4641-E0009DDC4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D4D84A-1690-F832-BFA9-E8711752F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93544-0A2C-CFE7-883C-623F58906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663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071342-DB91-CB0E-FBD7-1487FC0C09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AF7308-82EC-FCA8-639C-60121B13FF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90EADB-0F78-123C-AFDE-D12A3BD2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233F3-0AD8-4C65-68E2-2A52F9D3C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68BE24-0109-A041-5BE8-E288289E6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884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C522F-975A-308E-199D-A6A66AE43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807D2A-014E-1914-367F-1CD78D8C05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DD09DE-F46A-A660-A7ED-63D7D77C7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A2A4D-7306-4F98-ED80-2C182B8FF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989BEE-221C-5DA4-8327-C70F79AD6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059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8A57F-72F6-56F1-EAE9-4D94671B0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182B40-AD7C-AA23-336E-53AEFDD8ED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40DFEC-BB60-08B1-8B35-757909C051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AC6F7D-781A-8DFF-75D4-CBC24DAFF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5E1244-9233-1BCA-26E2-9D7234833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7C3BDC-BA5A-7A1A-343C-D53B8E077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364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384C2-4D4E-A6AF-CB4D-F9F091314A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0CDB62-C08B-F1D0-CEBB-5AFD5F82C4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ACF322-69DC-7DE4-EC26-F0C585DB1C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534B28-C064-5901-54DC-737AB30A81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613646-EDB6-6EFC-6AF9-EA7188ED87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439F1C-8DC4-D0C4-40D6-366683CE80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4FD569-9FCD-7DFD-07EE-57EF02031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80C69A-10E9-9850-1055-16DC94D18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699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DCDE6-2CA7-481A-763B-C09C88D540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A9AB55-EBBD-7160-5EBE-CD2B2D3BE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4EE6C1-5010-1B49-8B5F-218AC687D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88A10-E5E0-4378-F21A-9ED3AD9B4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739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001B95E-34C9-1C48-5640-2712314FE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5E1E6B-792C-06BC-0C21-33EF6A9E6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8EABF6-762D-2831-4A83-3C118692A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57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99B1C2-F71D-B5C8-3ECD-6F4E9E3D21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CFFD2B-07A0-C833-734E-478AACBA94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4802DB-0460-663C-B7BF-6A36817A45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1E3EED-78BF-873A-2054-B2DEFA38C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356FEC-4A29-89A1-9A4F-D978A0CAE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63F774-1038-7EF4-3D84-479F82D24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499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E46BF-E5C7-7DCC-D510-7CFC8E8AF8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E76BA0-A589-0A7A-EBB4-648E54BBDD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3FCD48-3ED0-47B1-3C57-0763295468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3C87DB-E7E4-E521-51AF-815048E96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A03772-F329-FFFD-5E78-D63C0F75F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807E70-F8F4-3563-E4A6-BB16DAE34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804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C758FD-8E45-3268-8925-A027003D1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1DB415-FCA2-1B3B-3B10-32FAB7B1F3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8DFA63-3B4E-8ECC-2F69-B6BDA61C7A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6DDBF-68D3-4831-80C0-734D3B4097F0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8C179A-E0A7-F012-9C30-BB9F11046B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5609DD-8E9C-F349-C206-71C1F08ED7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EAF16-8AF0-4B39-9AEB-B0BB410A14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186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105539F-CFB0-8453-9F01-5F8B2D3BB1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0994" y="2334097"/>
            <a:ext cx="1279888" cy="8281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9749CCC-B8DA-BC5D-3D4D-BD6149D8BC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886" y="2091466"/>
            <a:ext cx="1214545" cy="110893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8AED0DF-A9FA-8325-8ED9-5D8DDA7DF9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822" y="2263576"/>
            <a:ext cx="1008765" cy="9692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BF06CAA-838F-87F7-0B09-1C5E490846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502" y="2120750"/>
            <a:ext cx="809625" cy="118552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857851D-3EC5-E96D-FB69-AC2F806D551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8" t="14231" r="2514" b="14121"/>
          <a:stretch>
            <a:fillRect/>
          </a:stretch>
        </p:blipFill>
        <p:spPr>
          <a:xfrm>
            <a:off x="7844382" y="0"/>
            <a:ext cx="3849403" cy="209146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3CAAE3E-E5C8-CF01-FF9D-79B1CA785EC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58" r="20154" b="2975"/>
          <a:stretch>
            <a:fillRect/>
          </a:stretch>
        </p:blipFill>
        <p:spPr>
          <a:xfrm>
            <a:off x="7710865" y="2932584"/>
            <a:ext cx="3515369" cy="365109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3A4CA2C-C298-5335-23B3-2E4753CC2BE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991" y="4376869"/>
            <a:ext cx="3054308" cy="111451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A87DE0B-612A-F37A-ED02-441D3C78D06C}"/>
              </a:ext>
            </a:extLst>
          </p:cNvPr>
          <p:cNvSpPr txBox="1"/>
          <p:nvPr/>
        </p:nvSpPr>
        <p:spPr>
          <a:xfrm>
            <a:off x="900327" y="3203916"/>
            <a:ext cx="137037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ger millet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634B7EC-13BC-C54F-51AB-4C78B02BF70F}"/>
              </a:ext>
            </a:extLst>
          </p:cNvPr>
          <p:cNvSpPr txBox="1"/>
          <p:nvPr/>
        </p:nvSpPr>
        <p:spPr>
          <a:xfrm>
            <a:off x="2548314" y="3117160"/>
            <a:ext cx="9957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inding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BE01D2F-BD8A-389D-2A03-250B30FCAD25}"/>
              </a:ext>
            </a:extLst>
          </p:cNvPr>
          <p:cNvSpPr txBox="1"/>
          <p:nvPr/>
        </p:nvSpPr>
        <p:spPr>
          <a:xfrm>
            <a:off x="3556440" y="3269560"/>
            <a:ext cx="181652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ion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paration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Soxhlet metho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F81C02C-F615-8CE0-F696-4AE25B241584}"/>
              </a:ext>
            </a:extLst>
          </p:cNvPr>
          <p:cNvSpPr txBox="1"/>
          <p:nvPr/>
        </p:nvSpPr>
        <p:spPr>
          <a:xfrm>
            <a:off x="584861" y="5518044"/>
            <a:ext cx="235301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identification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nger mille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6308618-B0FF-AEF9-C651-6DCD020EEC1A}"/>
              </a:ext>
            </a:extLst>
          </p:cNvPr>
          <p:cNvSpPr txBox="1"/>
          <p:nvPr/>
        </p:nvSpPr>
        <p:spPr>
          <a:xfrm>
            <a:off x="5520402" y="3098400"/>
            <a:ext cx="1569660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omics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-HRMS/MS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o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7F252A2-0CA7-3075-69DE-8E9807ECAEFF}"/>
              </a:ext>
            </a:extLst>
          </p:cNvPr>
          <p:cNvSpPr txBox="1"/>
          <p:nvPr/>
        </p:nvSpPr>
        <p:spPr>
          <a:xfrm>
            <a:off x="7380145" y="2097247"/>
            <a:ext cx="4321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of compounds identified by </a:t>
            </a:r>
          </a:p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-HRMS/MS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E88D45D-84E5-6769-E1AE-1840D92C527F}"/>
              </a:ext>
            </a:extLst>
          </p:cNvPr>
          <p:cNvSpPr txBox="1"/>
          <p:nvPr/>
        </p:nvSpPr>
        <p:spPr>
          <a:xfrm>
            <a:off x="8523722" y="6529655"/>
            <a:ext cx="32645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athways </a:t>
            </a:r>
          </a:p>
        </p:txBody>
      </p:sp>
      <p:sp>
        <p:nvSpPr>
          <p:cNvPr id="32" name="Arrow: Right 31">
            <a:extLst>
              <a:ext uri="{FF2B5EF4-FFF2-40B4-BE49-F238E27FC236}">
                <a16:creationId xmlns:a16="http://schemas.microsoft.com/office/drawing/2014/main" id="{DA8585CA-6C93-52FA-A98E-CE37C04EBAC4}"/>
              </a:ext>
            </a:extLst>
          </p:cNvPr>
          <p:cNvSpPr/>
          <p:nvPr/>
        </p:nvSpPr>
        <p:spPr>
          <a:xfrm>
            <a:off x="2166426" y="2608456"/>
            <a:ext cx="311408" cy="2881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Arrow: Right 32">
            <a:extLst>
              <a:ext uri="{FF2B5EF4-FFF2-40B4-BE49-F238E27FC236}">
                <a16:creationId xmlns:a16="http://schemas.microsoft.com/office/drawing/2014/main" id="{591C0A3F-84AF-19DD-3C14-50FBD9D43FB2}"/>
              </a:ext>
            </a:extLst>
          </p:cNvPr>
          <p:cNvSpPr/>
          <p:nvPr/>
        </p:nvSpPr>
        <p:spPr>
          <a:xfrm>
            <a:off x="3655257" y="2620176"/>
            <a:ext cx="311408" cy="2881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Arrow: Right 33">
            <a:extLst>
              <a:ext uri="{FF2B5EF4-FFF2-40B4-BE49-F238E27FC236}">
                <a16:creationId xmlns:a16="http://schemas.microsoft.com/office/drawing/2014/main" id="{02FB065B-EA26-5DC6-0D0E-41C414E5F47D}"/>
              </a:ext>
            </a:extLst>
          </p:cNvPr>
          <p:cNvSpPr/>
          <p:nvPr/>
        </p:nvSpPr>
        <p:spPr>
          <a:xfrm>
            <a:off x="4949488" y="2634244"/>
            <a:ext cx="311408" cy="2881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Arrow: Right 34">
            <a:extLst>
              <a:ext uri="{FF2B5EF4-FFF2-40B4-BE49-F238E27FC236}">
                <a16:creationId xmlns:a16="http://schemas.microsoft.com/office/drawing/2014/main" id="{E91F6BB8-B442-E00C-23F3-C2B952F2C7A9}"/>
              </a:ext>
            </a:extLst>
          </p:cNvPr>
          <p:cNvSpPr/>
          <p:nvPr/>
        </p:nvSpPr>
        <p:spPr>
          <a:xfrm rot="19504684">
            <a:off x="7059639" y="2113749"/>
            <a:ext cx="311408" cy="2881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Arrow: Right 35">
            <a:extLst>
              <a:ext uri="{FF2B5EF4-FFF2-40B4-BE49-F238E27FC236}">
                <a16:creationId xmlns:a16="http://schemas.microsoft.com/office/drawing/2014/main" id="{15B3A2BC-B3A7-BD31-5DD0-0905A8E47374}"/>
              </a:ext>
            </a:extLst>
          </p:cNvPr>
          <p:cNvSpPr/>
          <p:nvPr/>
        </p:nvSpPr>
        <p:spPr>
          <a:xfrm rot="911235">
            <a:off x="7200320" y="3225090"/>
            <a:ext cx="311408" cy="2881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Arrow: Right 36">
            <a:extLst>
              <a:ext uri="{FF2B5EF4-FFF2-40B4-BE49-F238E27FC236}">
                <a16:creationId xmlns:a16="http://schemas.microsoft.com/office/drawing/2014/main" id="{415E3445-13FD-C96E-E387-E9B7743FA32D}"/>
              </a:ext>
            </a:extLst>
          </p:cNvPr>
          <p:cNvSpPr/>
          <p:nvPr/>
        </p:nvSpPr>
        <p:spPr>
          <a:xfrm rot="5400000">
            <a:off x="1474763" y="3998812"/>
            <a:ext cx="311408" cy="28811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833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ukesh sharma</dc:creator>
  <cp:lastModifiedBy>mukesh sharma</cp:lastModifiedBy>
  <cp:revision>1</cp:revision>
  <dcterms:created xsi:type="dcterms:W3CDTF">2025-11-04T16:36:53Z</dcterms:created>
  <dcterms:modified xsi:type="dcterms:W3CDTF">2025-11-04T16:37:35Z</dcterms:modified>
</cp:coreProperties>
</file>